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1"/>
  </p:notesMasterIdLst>
  <p:sldIdLst>
    <p:sldId id="366" r:id="rId2"/>
    <p:sldId id="408" r:id="rId3"/>
    <p:sldId id="409" r:id="rId4"/>
    <p:sldId id="375" r:id="rId5"/>
    <p:sldId id="276" r:id="rId6"/>
    <p:sldId id="369" r:id="rId7"/>
    <p:sldId id="370" r:id="rId8"/>
    <p:sldId id="284" r:id="rId9"/>
    <p:sldId id="286" r:id="rId10"/>
    <p:sldId id="373" r:id="rId11"/>
    <p:sldId id="287" r:id="rId12"/>
    <p:sldId id="288" r:id="rId13"/>
    <p:sldId id="400" r:id="rId14"/>
    <p:sldId id="404" r:id="rId15"/>
    <p:sldId id="378" r:id="rId16"/>
    <p:sldId id="397" r:id="rId17"/>
    <p:sldId id="371" r:id="rId18"/>
    <p:sldId id="407" r:id="rId19"/>
    <p:sldId id="410" r:id="rId20"/>
  </p:sldIdLst>
  <p:sldSz cx="6858000" cy="9144000" type="screen4x3"/>
  <p:notesSz cx="6808788" cy="99409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322" autoAdjust="0"/>
    <p:restoredTop sz="94660"/>
  </p:normalViewPr>
  <p:slideViewPr>
    <p:cSldViewPr>
      <p:cViewPr>
        <p:scale>
          <a:sx n="70" d="100"/>
          <a:sy n="70" d="100"/>
        </p:scale>
        <p:origin x="3084" y="16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notesMaster" Target="notesMasters/notesMaster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50475" cy="49704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6737" y="0"/>
            <a:ext cx="2950475" cy="49704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A1E685C-FE02-409C-9629-04ED0CC0D5E5}" type="datetimeFigureOut">
              <a:rPr lang="en-GB" smtClean="0"/>
              <a:t>25/02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6600" y="746125"/>
            <a:ext cx="2795588" cy="3727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0879" y="4721940"/>
            <a:ext cx="5447030" cy="4473416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42154"/>
            <a:ext cx="2950475" cy="49704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6737" y="9442154"/>
            <a:ext cx="2950475" cy="49704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E29E76A-C121-4744-BCA8-CCB0DB0146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32675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E29E76A-C121-4744-BCA8-CCB0DB014635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19439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FCD14-DE79-4C69-9B44-D2FD32AAECFE}" type="datetimeFigureOut">
              <a:rPr lang="en-GB" smtClean="0"/>
              <a:t>25/02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168538-A37C-4A86-A596-4A4144727C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27846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FCD14-DE79-4C69-9B44-D2FD32AAECFE}" type="datetimeFigureOut">
              <a:rPr lang="en-GB" smtClean="0"/>
              <a:t>25/02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168538-A37C-4A86-A596-4A4144727C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74878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FCD14-DE79-4C69-9B44-D2FD32AAECFE}" type="datetimeFigureOut">
              <a:rPr lang="en-GB" smtClean="0"/>
              <a:t>25/02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168538-A37C-4A86-A596-4A4144727C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2909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FCD14-DE79-4C69-9B44-D2FD32AAECFE}" type="datetimeFigureOut">
              <a:rPr lang="en-GB" smtClean="0"/>
              <a:t>25/02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168538-A37C-4A86-A596-4A4144727C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28960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FCD14-DE79-4C69-9B44-D2FD32AAECFE}" type="datetimeFigureOut">
              <a:rPr lang="en-GB" smtClean="0"/>
              <a:t>25/02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168538-A37C-4A86-A596-4A4144727C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24358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FCD14-DE79-4C69-9B44-D2FD32AAECFE}" type="datetimeFigureOut">
              <a:rPr lang="en-GB" smtClean="0"/>
              <a:t>25/02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168538-A37C-4A86-A596-4A4144727C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04859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FCD14-DE79-4C69-9B44-D2FD32AAECFE}" type="datetimeFigureOut">
              <a:rPr lang="en-GB" smtClean="0"/>
              <a:t>25/02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168538-A37C-4A86-A596-4A4144727C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76782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FCD14-DE79-4C69-9B44-D2FD32AAECFE}" type="datetimeFigureOut">
              <a:rPr lang="en-GB" smtClean="0"/>
              <a:t>25/02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168538-A37C-4A86-A596-4A4144727C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2007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FCD14-DE79-4C69-9B44-D2FD32AAECFE}" type="datetimeFigureOut">
              <a:rPr lang="en-GB" smtClean="0"/>
              <a:t>25/02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168538-A37C-4A86-A596-4A4144727C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62434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FCD14-DE79-4C69-9B44-D2FD32AAECFE}" type="datetimeFigureOut">
              <a:rPr lang="en-GB" smtClean="0"/>
              <a:t>25/02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168538-A37C-4A86-A596-4A4144727C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55167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FCD14-DE79-4C69-9B44-D2FD32AAECFE}" type="datetimeFigureOut">
              <a:rPr lang="en-GB" smtClean="0"/>
              <a:t>25/02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168538-A37C-4A86-A596-4A4144727C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097992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7FCD14-DE79-4C69-9B44-D2FD32AAECFE}" type="datetimeFigureOut">
              <a:rPr lang="en-GB" smtClean="0"/>
              <a:t>25/02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168538-A37C-4A86-A596-4A4144727C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69760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/>
          <p:cNvSpPr txBox="1"/>
          <p:nvPr/>
        </p:nvSpPr>
        <p:spPr>
          <a:xfrm>
            <a:off x="430243" y="220368"/>
            <a:ext cx="580706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. Effect of collagen hydrogels on the transfection efficiency of GET nanoparticles in pre-transfected NIH3t3 cells.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D8499F0-10C2-FF6E-CC96-3EF1D6120BE8}"/>
              </a:ext>
            </a:extLst>
          </p:cNvPr>
          <p:cNvSpPr txBox="1"/>
          <p:nvPr/>
        </p:nvSpPr>
        <p:spPr>
          <a:xfrm>
            <a:off x="612993" y="6521092"/>
            <a:ext cx="5691258" cy="15465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Figure S1. Effect of collagen hydrogels on the transfection efficiency of GET-</a:t>
            </a:r>
            <a:r>
              <a:rPr lang="en-GB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pDNA</a:t>
            </a:r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 for IN format or pre-transfected NIH3t3 cells.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A) Luciferase assay of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pGluc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pDNA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transfected as monolayer or by placing the transfection formulation within (IN) collagen hydrogels (2-6mg/ml) using FLR:FLH at 24h using 1X dose (1µg/ml). B) Metabolic activity (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PrestoBlue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) of NIH3t3 cell monolayers or collagen cells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untransfected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or transfected as in A). C) Luciferase assay of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pGluc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pDNA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pre-transfected NIH3t3 cells in monolayers or in collagen hydrogels (2-6mg/ml) using FLR:FLH at 24h using 1X dose (1µg/ml). D) Metabolic activity (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PrestoBlue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) of NIH3t3 cell monolayers or collagen cells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untransfected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or transfected as in C). </a:t>
            </a:r>
            <a:r>
              <a:rPr lang="en-GB" altLang="en-US" sz="1050" dirty="0" bmk="_Toc773824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ata was normalized to </a:t>
            </a:r>
            <a:r>
              <a:rPr lang="en-GB" altLang="en-US" sz="1050" dirty="0" err="1" bmk="_Toc773824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ntransfected</a:t>
            </a:r>
            <a:r>
              <a:rPr lang="en-GB" altLang="en-US" sz="1050" dirty="0" bmk="_Toc773824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</a:t>
            </a:r>
            <a:r>
              <a:rPr lang="en-GB" altLang="en-US" sz="1050" dirty="0" err="1" bmk="_Toc773824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ntr</a:t>
            </a:r>
            <a:r>
              <a:rPr lang="en-GB" altLang="en-US" sz="1050" dirty="0" bmk="_Toc773824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as 100%. (N=6, bars are S.D. ** p&lt;0.01, * p&lt;0.05).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41AC56F7-6277-2137-C353-8D247AA163C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0454" y="847923"/>
            <a:ext cx="6045658" cy="55072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293609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04664" y="395536"/>
            <a:ext cx="61926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0. Effect of orientation of 0.4µm membrane on transfection of NIH3t3 cells in collagen hydrogel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5BBE1C4-F94D-8519-028A-6243087BA46A}"/>
              </a:ext>
            </a:extLst>
          </p:cNvPr>
          <p:cNvSpPr txBox="1"/>
          <p:nvPr/>
        </p:nvSpPr>
        <p:spPr>
          <a:xfrm>
            <a:off x="498698" y="6348122"/>
            <a:ext cx="5709276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Figure S10. Effect of orientation of 0.4µm membrane on transfection of NIH3t3 cells in collagen hydrogels.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A) Schematic of the orientation and top/bottom volumes termed ‘conventional’ and ‘inverted’ used for assessing the effect of a 0.4µm membrane on transfection of collagen hydrogels.. B) Luciferase assay of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pGluc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pDNA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transfection using FLR:FLH 1X dose delivered to collagen gels measured from top or bottom media locations at day 1 (1µg/ml) without pressure differential. C) Luciferase assay of collagen hydrogels generated with pre-transfected NIH3t3 cells (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pGluc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pDNA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 using FLR:FLH 1X dose) measured from top or bottom media locations with NP differential (0 to -150 mmHg) at day 1 post-seeding (day 2 post-transfection) (1µg/ml.)  D) Luciferase assay of collagen hydrogels generated with pre-transfected NIH3t3 (5x10</a:t>
            </a:r>
            <a:r>
              <a:rPr lang="en-GB" sz="105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) cells without pressure (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pGluc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pDNA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 using FLR:FLH 1X dose) measured from top or bottom media locations at day 1 post-seeding (day 2 post-transfection) (1µg/ml.).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Untransfected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Untr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GB" altLang="en-US" sz="1050" dirty="0" bmk="_Toc773824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N=6, bars are S.D. ** p&lt;0.01, * p&lt;0.05).</a:t>
            </a:r>
            <a:endParaRPr lang="en-GB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2" name="Picture 81">
            <a:extLst>
              <a:ext uri="{FF2B5EF4-FFF2-40B4-BE49-F238E27FC236}">
                <a16:creationId xmlns:a16="http://schemas.microsoft.com/office/drawing/2014/main" id="{C385F8AB-D6B8-893D-E2B0-D171F0B4B8C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6846" y="1045688"/>
            <a:ext cx="6150884" cy="50579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2109124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TextBox 43"/>
          <p:cNvSpPr txBox="1"/>
          <p:nvPr/>
        </p:nvSpPr>
        <p:spPr>
          <a:xfrm>
            <a:off x="404664" y="395536"/>
            <a:ext cx="61926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1. Transfer of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DNA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or GET nanoparticles through a 0.4µm membrane with NP differential using fluorometry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C3DF6C8-080E-3A53-B138-6DABC7916E1F}"/>
              </a:ext>
            </a:extLst>
          </p:cNvPr>
          <p:cNvSpPr txBox="1"/>
          <p:nvPr/>
        </p:nvSpPr>
        <p:spPr>
          <a:xfrm>
            <a:off x="630142" y="4788024"/>
            <a:ext cx="5741732" cy="9002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Figure S11. Transfer of </a:t>
            </a:r>
            <a:r>
              <a:rPr lang="en-GB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pDNA</a:t>
            </a:r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 or GET nanoparticles through a 0.4µm membrane with NP differential using fluorometry.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Fluorometry assay of Rhodamine-labelled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pDNA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pDNA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) or GET nanoparticles (generated using FLR:FLH and Rhodamine-labelled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pDNA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) transfected from top or bottom and measured from top or bottom media locations with NP differential (0 to -150 mmHg) </a:t>
            </a:r>
            <a:r>
              <a:rPr lang="en-GB" altLang="en-US" sz="1050" dirty="0" bmk="_Toc773824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N=6, bars are S.D. ** p&lt;0.01, * p&lt;0.05).</a:t>
            </a:r>
            <a:endParaRPr lang="en-GB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26BBC184-A74C-B8CE-B088-20B353BC312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4664" y="1052811"/>
            <a:ext cx="5895343" cy="34811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7580736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TextBox 74"/>
          <p:cNvSpPr txBox="1"/>
          <p:nvPr/>
        </p:nvSpPr>
        <p:spPr>
          <a:xfrm>
            <a:off x="305290" y="208056"/>
            <a:ext cx="61926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2. Transfer of GET peptide, GET nanoparticles or Dextran through a 0.4µm membrane with NP differential using fluorometry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46EEFAB-D7D2-A426-C0E7-2B2C0604F0AF}"/>
              </a:ext>
            </a:extLst>
          </p:cNvPr>
          <p:cNvSpPr txBox="1"/>
          <p:nvPr/>
        </p:nvSpPr>
        <p:spPr>
          <a:xfrm>
            <a:off x="495580" y="7596336"/>
            <a:ext cx="5957756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Figure S12. Transfer of GET peptide, GET nanoparticles or Dextran through a 0.4µm membrane with NP differential using fluorometry.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A) Fluorometry assay of Rhodamine-labelled FLR:FLH (FLR labelled) or GET nanoparticles (generated using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pDNA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and Rhodamine-labelled FLR:FLH) transfected from top or bottom and measured from top or bottom media locations with NP differential (0 to -150 mmHg) B. Fluorometry assay with TRITC-labelled Dextran (5.5kDa) </a:t>
            </a:r>
            <a:r>
              <a:rPr lang="en-GB" altLang="en-US" sz="1050" dirty="0" bmk="_Toc773824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N=6, bars are S.D. ** p&lt;0.01, * p&lt;0.05).</a:t>
            </a:r>
            <a:endParaRPr lang="en-GB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C9E3B1EE-1E57-7230-48C0-2E3E7348042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7493" y="822613"/>
            <a:ext cx="5828281" cy="66208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9075089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13CA8CD3-8BAA-7C34-5019-AD8720CAFF81}"/>
              </a:ext>
            </a:extLst>
          </p:cNvPr>
          <p:cNvSpPr txBox="1"/>
          <p:nvPr/>
        </p:nvSpPr>
        <p:spPr>
          <a:xfrm>
            <a:off x="788792" y="4572000"/>
            <a:ext cx="5256584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Figure S13. Metabolic activity of cells when assessing dose and volume in transfection.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Metabolic assessment of cells transfected with GFP reporter with different doses (0,(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Untransfected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Untr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), 0.2X, 1X and 5X in different volumes (1.5, 15 and 45ml) in collagen gels (2mg/ml) as in Figure 4C. After pressure application media replaced (0.5ml top, 1.5ml bottom) with GFP measured by flow cytometry in collagenase-recovered cells, and metabolic activity measured after 24h. NP differentials (0 to -150 mmHg) with 3µm pore-size nylon mesh wells were used </a:t>
            </a:r>
            <a:r>
              <a:rPr lang="en-GB" altLang="en-US" sz="1050" dirty="0" bmk="_Toc773824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N=6, bars are S.D. ** p&lt;0.01, * p&lt;0.05).</a:t>
            </a:r>
            <a:endParaRPr lang="en-GB" sz="105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1AFD0F2-0408-B0BB-2111-8808BA9E5D0F}"/>
              </a:ext>
            </a:extLst>
          </p:cNvPr>
          <p:cNvSpPr txBox="1"/>
          <p:nvPr/>
        </p:nvSpPr>
        <p:spPr>
          <a:xfrm>
            <a:off x="404664" y="107504"/>
            <a:ext cx="61926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3. Metabolic activity of cells when assessing dose and volume in transfection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AF41CC16-F897-198F-F011-4DDDE206330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44664" y="1062871"/>
            <a:ext cx="4968671" cy="31519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2526062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969B4180-DFEF-8848-48BC-17CF06AF4712}"/>
              </a:ext>
            </a:extLst>
          </p:cNvPr>
          <p:cNvSpPr txBox="1"/>
          <p:nvPr/>
        </p:nvSpPr>
        <p:spPr>
          <a:xfrm>
            <a:off x="404664" y="107504"/>
            <a:ext cx="61926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4. Metabolic activity of cells when assessing collagen density in transfection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07EC277-DAB6-584B-80DD-E8F11E024C65}"/>
              </a:ext>
            </a:extLst>
          </p:cNvPr>
          <p:cNvSpPr txBox="1"/>
          <p:nvPr/>
        </p:nvSpPr>
        <p:spPr>
          <a:xfrm>
            <a:off x="721333" y="3779912"/>
            <a:ext cx="5415333" cy="12234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Figure S14. Metabolic activity of cells when assessing collagen density in transfection.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Metabolic assessment of cells transfected Assessment of different collagen concentrations (2, 4, 6mg/ml) with 1.5ml volume and 1X dose.(as in Figure 4B). After pressure application media replaced (0.5ml top, 1.5ml bottom) with GFP measured by flow cytometry in collagenase-recovered cells, and metabolic activity measured after 24h. NP differentials (0 to -150 mmHg) with 3µm pore-size nylon mesh wells were used </a:t>
            </a:r>
            <a:r>
              <a:rPr lang="en-GB" altLang="en-US" sz="1050" dirty="0" bmk="_Toc773824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N=6, bars are S.D. ** p&lt;0.01, * p&lt;0.05).</a:t>
            </a:r>
            <a:endParaRPr lang="en-GB" sz="1050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ACF4120-C561-E3A4-AE3B-5330E9C8F38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22648" y="822756"/>
            <a:ext cx="4212701" cy="27251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5830283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B1E89CF9-E50D-6976-51A1-96C757AE1A90}"/>
              </a:ext>
            </a:extLst>
          </p:cNvPr>
          <p:cNvSpPr txBox="1"/>
          <p:nvPr/>
        </p:nvSpPr>
        <p:spPr>
          <a:xfrm>
            <a:off x="404664" y="107504"/>
            <a:ext cx="61926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5. Pressure differential-delivered GET nanoparticles are sequestered by cell membrane binding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FCAC648-F735-6B66-4F95-48DCB0C06C17}"/>
              </a:ext>
            </a:extLst>
          </p:cNvPr>
          <p:cNvSpPr txBox="1"/>
          <p:nvPr/>
        </p:nvSpPr>
        <p:spPr>
          <a:xfrm>
            <a:off x="404664" y="5120724"/>
            <a:ext cx="5957756" cy="12234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Figure S15. Pressure differential-delivered GET nanoparticles are sequestered by cell membrane binding.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Fluorometry assay of Rhodamine-labelled GET nanoparticles (FLR:FLH and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pDNA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) employing A-B) Rhodamine-labelled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pDNA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or C-D) FLR. Transfections of collagen hydrogels contained live or fixed NIH3t3 cells. GET nanoparticles were delivered from bottom and measured from A) and C) top collection media; or B) and D) in collagen (direct fluorescence of collagen) with NP differential (0 to -150 mmHg) using 3µm pore-size nylon mesh wells </a:t>
            </a:r>
            <a:r>
              <a:rPr lang="en-GB" altLang="en-US" sz="1050" dirty="0" bmk="_Toc773824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N=6, bars are S.D. ** p&lt;0.01, * p&lt;0.05).</a:t>
            </a:r>
            <a:endParaRPr lang="en-GB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75E59E37-B9C4-9C39-7023-C0C2015F95B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1963" y="722501"/>
            <a:ext cx="6194073" cy="41700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8408671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TextBox 31">
            <a:extLst>
              <a:ext uri="{FF2B5EF4-FFF2-40B4-BE49-F238E27FC236}">
                <a16:creationId xmlns:a16="http://schemas.microsoft.com/office/drawing/2014/main" id="{0E0A7600-2C72-F299-861C-877DE466237B}"/>
              </a:ext>
            </a:extLst>
          </p:cNvPr>
          <p:cNvSpPr txBox="1"/>
          <p:nvPr/>
        </p:nvSpPr>
        <p:spPr>
          <a:xfrm>
            <a:off x="394765" y="231804"/>
            <a:ext cx="61926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6. Sequestering pressure differential-delivered GET nanoparticles by cell membrane binding is inhibited by heparin and proportional to cell number.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27B0C00-D489-6A0E-152C-E37505CF46AD}"/>
              </a:ext>
            </a:extLst>
          </p:cNvPr>
          <p:cNvSpPr txBox="1"/>
          <p:nvPr/>
        </p:nvSpPr>
        <p:spPr>
          <a:xfrm>
            <a:off x="308169" y="5532173"/>
            <a:ext cx="6192688" cy="1708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Figure S16. Sequestering pressure differential-delivered GET nanoparticles by cell membrane binding is inhibited by heparin and proportional to cell number.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Fluorometry assay of Rhodamine-labelled GET nanoparticles (FLR:FLH and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pDNA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) employing Rhodamine-labelled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pDNA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in the presence of Heparin (100µg/ml). Transfections of collagen hydrogels contained live or fixed NIH3t3 cells. GET nanoparticles were delivered from bottom and measured from A) top collection media or B) in collagen gels. Rhodamine-labelled FLR and FLH) transfected collagen hydrogels containing different densities of NIH3t3 cells (none to 10</a:t>
            </a:r>
            <a:r>
              <a:rPr lang="en-GB" sz="105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). GET nanoparticles were delivered from bottom and measured from C) top collection media; or D) in collagen (direct fluorescence of collagen) with NP differential (0 to -150 mmHg). Experiments used 3µm pore-size nylon mesh wells </a:t>
            </a:r>
            <a:r>
              <a:rPr lang="en-GB" altLang="en-US" sz="1050" dirty="0" bmk="_Toc773824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N=6, bars are S.D. ** p&lt;0.01, * p&lt;0.05).</a:t>
            </a:r>
            <a:endParaRPr lang="en-GB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7" name="Picture 46">
            <a:extLst>
              <a:ext uri="{FF2B5EF4-FFF2-40B4-BE49-F238E27FC236}">
                <a16:creationId xmlns:a16="http://schemas.microsoft.com/office/drawing/2014/main" id="{C6601022-541B-EBEC-16D5-6D86E5E8FA6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9959" y="1187624"/>
            <a:ext cx="6157494" cy="41700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5379171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TextBox 44"/>
          <p:cNvSpPr txBox="1"/>
          <p:nvPr/>
        </p:nvSpPr>
        <p:spPr>
          <a:xfrm>
            <a:off x="404664" y="395536"/>
            <a:ext cx="61926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7. GET nanoparticles require pressure differentials and flow into hydrogels for enhanced transfection.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1E7BD7A-5D3F-06A5-66C4-D0FF21AB6F74}"/>
              </a:ext>
            </a:extLst>
          </p:cNvPr>
          <p:cNvSpPr txBox="1"/>
          <p:nvPr/>
        </p:nvSpPr>
        <p:spPr>
          <a:xfrm>
            <a:off x="679421" y="4284081"/>
            <a:ext cx="549915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Figure S17. GET nanoparticles require pressure differentials and flow into hydrogels for enhanced transfection.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A) Schematic of the orientation and top/bottom transfections termed ‘Opposite’ and ‘Same’ used for assessing the effect of application side for transfection of collagen hydrogels using NP. B) </a:t>
            </a:r>
            <a:r>
              <a:rPr lang="en-GB" altLang="en-US" sz="1050" dirty="0" bmk="_Toc773824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uciferase assay using NP differential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using FLR:FLH transfected from bottom (Opposite) or top (Same) and measured from top media locations with NP differential (0 to -150 mmHg) with 3µm pore-size nylon mesh wells </a:t>
            </a:r>
            <a:r>
              <a:rPr lang="en-GB" altLang="en-US" sz="1050" dirty="0" bmk="_Toc773824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N=6, bars are S.D. ** p&lt;0.01, * p&lt;0.05). Transfection conditions were as used in Figure S6.</a:t>
            </a:r>
            <a:endParaRPr lang="en-GB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E1B8B139-CB4D-E3C2-C7E5-DB1096EA887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7052" y="1058702"/>
            <a:ext cx="5803895" cy="30238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78573466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TextBox 42">
            <a:extLst>
              <a:ext uri="{FF2B5EF4-FFF2-40B4-BE49-F238E27FC236}">
                <a16:creationId xmlns:a16="http://schemas.microsoft.com/office/drawing/2014/main" id="{CDC70793-7B6B-BA84-85E8-1A3ED1770153}"/>
              </a:ext>
            </a:extLst>
          </p:cNvPr>
          <p:cNvSpPr txBox="1"/>
          <p:nvPr/>
        </p:nvSpPr>
        <p:spPr>
          <a:xfrm>
            <a:off x="332656" y="179512"/>
            <a:ext cx="619268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8. Quantification of diffusion of TAMRA-FLR labelled GET-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DNA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transfection in NIH3t3-laden collagen gels with NP differential using confocal microscopy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1122FE10-108B-8539-57A5-D0C695B520B6}"/>
              </a:ext>
            </a:extLst>
          </p:cNvPr>
          <p:cNvSpPr txBox="1"/>
          <p:nvPr/>
        </p:nvSpPr>
        <p:spPr>
          <a:xfrm>
            <a:off x="548680" y="4999048"/>
            <a:ext cx="5468006" cy="12234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Figure S18. Quantification of diffusion of TAMRA-FLR labelled GET-</a:t>
            </a:r>
            <a:r>
              <a:rPr lang="en-GB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pDNA</a:t>
            </a:r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 transfection in NIH3t3-laden collagen gels with NP differential using confocal microscopy. </a:t>
            </a:r>
            <a:r>
              <a:rPr kumimoji="0" lang="en-GB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ocalization of GET-</a:t>
            </a:r>
            <a:r>
              <a:rPr kumimoji="0" lang="en-GB" altLang="en-US" sz="105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DNA</a:t>
            </a:r>
            <a:r>
              <a:rPr kumimoji="0" lang="en-GB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with labelled FLR, TM-FLR) after NP (-25 mmHg) application (as in Figure 8E) in </a:t>
            </a:r>
            <a:r>
              <a:rPr kumimoji="0" lang="en-GB" altLang="en-US" sz="105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ellularized</a:t>
            </a:r>
            <a:r>
              <a:rPr kumimoji="0" lang="en-GB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ollagen hydrogels was quantified by image analysis of signal intensity using Confocal microscopy with images collected at surface (0µm) and increasing depths (100-500µm) from delivered surface </a:t>
            </a:r>
            <a:r>
              <a:rPr lang="en-GB" altLang="en-US" sz="1050" dirty="0" bmk="_Toc773824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N=6, bars are S.D., ns is not significant,  ** p&lt;0.01, * p&lt;0.05).</a:t>
            </a:r>
            <a:endParaRPr lang="en-GB" sz="1050" dirty="0"/>
          </a:p>
        </p:txBody>
      </p:sp>
      <p:pic>
        <p:nvPicPr>
          <p:cNvPr id="45" name="Picture 44">
            <a:extLst>
              <a:ext uri="{FF2B5EF4-FFF2-40B4-BE49-F238E27FC236}">
                <a16:creationId xmlns:a16="http://schemas.microsoft.com/office/drawing/2014/main" id="{0FF0E846-BD6A-A070-F26C-991AD65E6AC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0648" y="1062763"/>
            <a:ext cx="6019676" cy="37833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58801766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6B39A4E-9D7E-42E1-4CD7-97B9B17C92C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TextBox 42">
            <a:extLst>
              <a:ext uri="{FF2B5EF4-FFF2-40B4-BE49-F238E27FC236}">
                <a16:creationId xmlns:a16="http://schemas.microsoft.com/office/drawing/2014/main" id="{DEBADFB5-C5AA-453D-389A-089D133AA7BF}"/>
              </a:ext>
            </a:extLst>
          </p:cNvPr>
          <p:cNvSpPr txBox="1"/>
          <p:nvPr/>
        </p:nvSpPr>
        <p:spPr>
          <a:xfrm>
            <a:off x="332656" y="179512"/>
            <a:ext cx="61926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9. Dose optimization for transfection </a:t>
            </a:r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of pig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kin explants </a:t>
            </a:r>
            <a:r>
              <a:rPr lang="en-GB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ex vivo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194D0279-37E7-A523-5941-42FBF0632A80}"/>
              </a:ext>
            </a:extLst>
          </p:cNvPr>
          <p:cNvSpPr txBox="1"/>
          <p:nvPr/>
        </p:nvSpPr>
        <p:spPr>
          <a:xfrm>
            <a:off x="642128" y="6876980"/>
            <a:ext cx="5667192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Figure S19. Dose optimization for transfection of pig skin explants </a:t>
            </a:r>
            <a:r>
              <a:rPr lang="en-GB" sz="1050" b="1" i="1" dirty="0">
                <a:latin typeface="Arial" panose="020B0604020202020204" pitchFamily="34" charset="0"/>
                <a:cs typeface="Arial" panose="020B0604020202020204" pitchFamily="34" charset="0"/>
              </a:rPr>
              <a:t>ex vivo</a:t>
            </a:r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kumimoji="0" lang="en-GB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GB" altLang="en-US" sz="10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Luciferase assay of GET-</a:t>
            </a:r>
            <a:r>
              <a:rPr lang="en-GB" altLang="en-US" sz="105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Gluc</a:t>
            </a:r>
            <a:r>
              <a:rPr lang="en-GB" altLang="en-US" sz="10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nanoparticles (generated using FLR:FLH) transfected with 1-8µg FLR:FLH transfection doses for 24h, measured at day 1-7 post-transfection) (N=6, bars are S.D. ** p&lt;0.01, * p&lt;0.05).. B) Metabolic activity (</a:t>
            </a:r>
            <a:r>
              <a:rPr lang="en-GB" altLang="en-US" sz="105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restoBlue</a:t>
            </a:r>
            <a:r>
              <a:rPr lang="en-GB" altLang="en-US" sz="10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experiment in B). Data was normalized to </a:t>
            </a:r>
            <a:r>
              <a:rPr lang="en-GB" altLang="en-US" sz="105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ntransfected</a:t>
            </a:r>
            <a:r>
              <a:rPr lang="en-GB" altLang="en-US" sz="10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</a:t>
            </a:r>
            <a:r>
              <a:rPr lang="en-GB" altLang="en-US" sz="105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ntr</a:t>
            </a:r>
            <a:r>
              <a:rPr lang="en-GB" altLang="en-US" sz="10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explants as 100%. (N=6, bars are S.D. ** p&lt;0.01, * p&lt;0.05).</a:t>
            </a:r>
            <a:endParaRPr lang="en-GB" sz="1050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9863F8E0-7490-C73B-F4B7-CC6BE2623A7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1599" y="755576"/>
            <a:ext cx="5919729" cy="59563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934335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TextBox 30">
            <a:extLst>
              <a:ext uri="{FF2B5EF4-FFF2-40B4-BE49-F238E27FC236}">
                <a16:creationId xmlns:a16="http://schemas.microsoft.com/office/drawing/2014/main" id="{1E16C02F-5B5F-B88A-204A-A7A50C3CB8A8}"/>
              </a:ext>
            </a:extLst>
          </p:cNvPr>
          <p:cNvSpPr txBox="1"/>
          <p:nvPr/>
        </p:nvSpPr>
        <p:spPr>
          <a:xfrm>
            <a:off x="332656" y="258125"/>
            <a:ext cx="619268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2. Quantification of diffusion of TAMRA-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DNA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labelled GET-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DNA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transfection in acellular collagen gels with NP differential using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ryosectioning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and fluorometry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229B440-5D54-22D1-D81A-CC1009312206}"/>
              </a:ext>
            </a:extLst>
          </p:cNvPr>
          <p:cNvSpPr txBox="1"/>
          <p:nvPr/>
        </p:nvSpPr>
        <p:spPr>
          <a:xfrm>
            <a:off x="548680" y="5965958"/>
            <a:ext cx="5688632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Figure S2. Quantification of diffusion of TAMRA-</a:t>
            </a:r>
            <a:r>
              <a:rPr lang="en-GB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pDNA</a:t>
            </a:r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 labelled GET-</a:t>
            </a:r>
            <a:r>
              <a:rPr lang="en-GB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pDNA</a:t>
            </a:r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 transfection in acellular collagen gels with NP differential using </a:t>
            </a:r>
            <a:r>
              <a:rPr lang="en-GB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cryosectioning</a:t>
            </a:r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 and fluorometry. </a:t>
            </a:r>
            <a:r>
              <a:rPr kumimoji="0" lang="en-GB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ocalization of GET-</a:t>
            </a:r>
            <a:r>
              <a:rPr kumimoji="0" lang="en-GB" altLang="en-US" sz="105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DNA</a:t>
            </a:r>
            <a:r>
              <a:rPr kumimoji="0" lang="en-GB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with labelled </a:t>
            </a:r>
            <a:r>
              <a:rPr kumimoji="0" lang="en-GB" altLang="en-US" sz="105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DNA</a:t>
            </a:r>
            <a:r>
              <a:rPr kumimoji="0" lang="en-GB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TAMRA-</a:t>
            </a:r>
            <a:r>
              <a:rPr kumimoji="0" lang="en-GB" altLang="en-US" sz="105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DNA</a:t>
            </a:r>
            <a:r>
              <a:rPr kumimoji="0" lang="en-GB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after NP (-25 mmHg) application (as in Figure 8E) in acellular collagen hydrogels was quantified by fluorometry of samples extracted from </a:t>
            </a:r>
            <a:r>
              <a:rPr kumimoji="0" lang="en-GB" altLang="en-US" sz="105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ryosectioned</a:t>
            </a:r>
            <a:r>
              <a:rPr kumimoji="0" lang="en-GB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gels. Gels were snap-frozen in liquid nitrogen, mounted and sectioned collecting 5 sections at surface (0µm) and increasing depths (100-500µm) from delivered surface. These were subjected to fluorometry to detect the TAMRA-FLR label </a:t>
            </a:r>
            <a:r>
              <a:rPr lang="en-GB" altLang="en-US" sz="1050" dirty="0" bmk="_Toc773824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N=6, bars are S.D., ns is not significant,  ** p&lt;0.01, * p&lt;0.05).</a:t>
            </a:r>
            <a:endParaRPr lang="en-GB" sz="1050" dirty="0"/>
          </a:p>
        </p:txBody>
      </p:sp>
      <p:pic>
        <p:nvPicPr>
          <p:cNvPr id="33" name="Picture 32">
            <a:extLst>
              <a:ext uri="{FF2B5EF4-FFF2-40B4-BE49-F238E27FC236}">
                <a16:creationId xmlns:a16="http://schemas.microsoft.com/office/drawing/2014/main" id="{55CABB30-1A30-43AF-69FD-AA971D756F6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2696" y="1050006"/>
            <a:ext cx="4886753" cy="43996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612134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>
            <a:extLst>
              <a:ext uri="{FF2B5EF4-FFF2-40B4-BE49-F238E27FC236}">
                <a16:creationId xmlns:a16="http://schemas.microsoft.com/office/drawing/2014/main" id="{E48B3200-0D0A-C817-C0C6-6866BA844590}"/>
              </a:ext>
            </a:extLst>
          </p:cNvPr>
          <p:cNvSpPr txBox="1"/>
          <p:nvPr/>
        </p:nvSpPr>
        <p:spPr>
          <a:xfrm>
            <a:off x="321478" y="394433"/>
            <a:ext cx="619268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3. Quantification of diffusion of TAMRA-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DNA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labelled GET-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DNA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and Lipofectamine-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DNA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transfection in acellular collagen gels using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ryosectioning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and fluorometry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2BBA8E3-5B72-5F0A-A346-08978638FA96}"/>
              </a:ext>
            </a:extLst>
          </p:cNvPr>
          <p:cNvSpPr txBox="1"/>
          <p:nvPr/>
        </p:nvSpPr>
        <p:spPr>
          <a:xfrm>
            <a:off x="598332" y="5965958"/>
            <a:ext cx="563898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Figure S3. Quantification of diffusion of TAMRA-</a:t>
            </a:r>
            <a:r>
              <a:rPr lang="en-GB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pDNA</a:t>
            </a:r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 labelled GET-</a:t>
            </a:r>
            <a:r>
              <a:rPr lang="en-GB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pDNA</a:t>
            </a:r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 and Lipofectamine-</a:t>
            </a:r>
            <a:r>
              <a:rPr lang="en-GB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pDNA</a:t>
            </a:r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 transfection in acellular collagen gels using </a:t>
            </a:r>
            <a:r>
              <a:rPr lang="en-GB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cryosectioning</a:t>
            </a:r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 and fluorometry. </a:t>
            </a:r>
            <a:r>
              <a:rPr kumimoji="0" lang="en-GB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ocalization of GET-</a:t>
            </a:r>
            <a:r>
              <a:rPr kumimoji="0" lang="en-GB" altLang="en-US" sz="105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DNA</a:t>
            </a:r>
            <a:r>
              <a:rPr kumimoji="0" lang="en-GB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r Lipofectamine 2000-pDNA (with labelled TAMRA-</a:t>
            </a:r>
            <a:r>
              <a:rPr kumimoji="0" lang="en-GB" altLang="en-US" sz="105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DNA</a:t>
            </a:r>
            <a:r>
              <a:rPr kumimoji="0" lang="en-GB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in acellular collagen hydrogels was quantified by fluorometry of samples extracted from </a:t>
            </a:r>
            <a:r>
              <a:rPr kumimoji="0" lang="en-GB" altLang="en-US" sz="105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ryosectioned</a:t>
            </a:r>
            <a:r>
              <a:rPr kumimoji="0" lang="en-GB" altLang="en-US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gels. Gels were snap-frozen in liquid nitrogen, mounted and sectioned collecting 5 sections at surface (0µm) and increasing depths (100-500µm) from delivered surface. These were subjected to fluorometry to detect the TAMRA-FLR label </a:t>
            </a:r>
            <a:r>
              <a:rPr lang="en-GB" altLang="en-US" sz="1050" dirty="0" bmk="_Toc773824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N=6, bars are S.D., ns is not significant,  ** p&lt;0.01, * p&lt;0.05).</a:t>
            </a:r>
            <a:endParaRPr lang="en-GB" sz="1050" dirty="0"/>
          </a:p>
        </p:txBody>
      </p:sp>
      <p:pic>
        <p:nvPicPr>
          <p:cNvPr id="27" name="Picture 26">
            <a:extLst>
              <a:ext uri="{FF2B5EF4-FFF2-40B4-BE49-F238E27FC236}">
                <a16:creationId xmlns:a16="http://schemas.microsoft.com/office/drawing/2014/main" id="{2D37FD65-10DA-CD84-2FD7-DC0E0BC51A3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8332" y="1492642"/>
            <a:ext cx="5241587" cy="43442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8866366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1C65A24D-8E61-D4A0-4E82-0368C1641529}"/>
              </a:ext>
            </a:extLst>
          </p:cNvPr>
          <p:cNvSpPr txBox="1"/>
          <p:nvPr/>
        </p:nvSpPr>
        <p:spPr>
          <a:xfrm>
            <a:off x="430243" y="220368"/>
            <a:ext cx="61926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4. Effect of transfection efficiency of GET nanoparticles in pre-transfected NIH3t3 cells and as a function of gel thicknes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9959EBC-0552-6BA3-B05D-B3CBAD09528B}"/>
              </a:ext>
            </a:extLst>
          </p:cNvPr>
          <p:cNvSpPr txBox="1"/>
          <p:nvPr/>
        </p:nvSpPr>
        <p:spPr>
          <a:xfrm>
            <a:off x="430243" y="6327022"/>
            <a:ext cx="5822929" cy="1708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Figure S4. Effect of collagen hydrogels on GFP transfection efficiency of GET nanoparticles in pre-transfected NIH3t3 cells.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A) GFP flow cytometry of GFP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pDNA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pre-transfected NIH3t3 cells in monolayers or in collagen hydrogels (2-6mg/ml) using FLR:FLH at 24h using 1X dose (1µg/ml). B) Metabolic activity (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PrestoBlue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) of NIH3t3 cell monolayers or collagen cells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untransfected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or transfected as in A). C) Luciferase assay of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pGluc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pDNA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transfected NIH3t3 cells (5x10</a:t>
            </a:r>
            <a:r>
              <a:rPr lang="en-GB" sz="105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) in monolayers or in collagen hydrogels (2mg/ml) in thin (20µl) or thick (100µl) geometries using FLR:FLH at 24h using 1X dose (1µg/ml). D) Metabolic activity (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PrestoBlue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) of NIH3t3 cell monolayers or collagen cells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untransfected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or transfected as in C). </a:t>
            </a:r>
            <a:r>
              <a:rPr lang="en-GB" altLang="en-US" sz="1050" dirty="0" bmk="_Toc773824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ata was normalized to </a:t>
            </a:r>
            <a:r>
              <a:rPr lang="en-GB" altLang="en-US" sz="1050" dirty="0" err="1" bmk="_Toc773824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ntransfected</a:t>
            </a:r>
            <a:r>
              <a:rPr lang="en-GB" altLang="en-US" sz="1050" dirty="0" bmk="_Toc773824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</a:t>
            </a:r>
            <a:r>
              <a:rPr lang="en-GB" altLang="en-US" sz="1050" dirty="0" err="1" bmk="_Toc773824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ntr</a:t>
            </a:r>
            <a:r>
              <a:rPr lang="en-GB" altLang="en-US" sz="1050" dirty="0" bmk="_Toc773824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as 100%. (N=6, bars are S.D. ** p&lt;0.01, * p&lt;0.05).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83AE2441-9A67-732B-E128-A3EC3E02231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1242" y="833260"/>
            <a:ext cx="6250388" cy="53617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0887079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TextBox 60"/>
          <p:cNvSpPr txBox="1"/>
          <p:nvPr/>
        </p:nvSpPr>
        <p:spPr>
          <a:xfrm>
            <a:off x="404664" y="395536"/>
            <a:ext cx="61926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5. Effect of collagen hydrogels on serial transfection efficiency of GET nanoparticles in NIH3t3 cells.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FD859DD-2B3D-A4F9-83AB-23D24D9D166C}"/>
              </a:ext>
            </a:extLst>
          </p:cNvPr>
          <p:cNvSpPr txBox="1"/>
          <p:nvPr/>
        </p:nvSpPr>
        <p:spPr>
          <a:xfrm>
            <a:off x="477883" y="7265760"/>
            <a:ext cx="576064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Figure S5. Effect of collagen hydrogels on serial transfection efficiency of GET nanoparticles and NIH3t3 cells.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A) GFP positive cells with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peGFP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pDNA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transfection using FLR:FLH 1X dose delivered once (Single, day 0), twice (double, day 0 &amp; 1) or three-times (triple, day 0, 1 and 2) to NIH3t3 monolayers and collagen gels with a 24 hour exposure, measured at day 1-3 (1µg/ml), respectively. B) Metabolic activity (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PrestoBlue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) of NIH3t3 cell monolayers and collagen hydrogels measured at day 1-3, respectively. </a:t>
            </a:r>
            <a:r>
              <a:rPr lang="en-GB" altLang="en-US" sz="1050" dirty="0" bmk="_Toc773824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ata was normalized to </a:t>
            </a:r>
            <a:r>
              <a:rPr lang="en-GB" altLang="en-US" sz="1050" dirty="0" err="1" bmk="_Toc773824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ntransfected</a:t>
            </a:r>
            <a:r>
              <a:rPr lang="en-GB" altLang="en-US" sz="1050" dirty="0" bmk="_Toc773824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</a:t>
            </a:r>
            <a:r>
              <a:rPr lang="en-GB" altLang="en-US" sz="1050" dirty="0" err="1" bmk="_Toc773824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ntr</a:t>
            </a:r>
            <a:r>
              <a:rPr lang="en-GB" altLang="en-US" sz="1050" dirty="0" bmk="_Toc773824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cells in either monolayer or collagen hydrogel formats as 100%. (N=6, bars are S.D. ** p&lt;0.01, * p&lt;0.05)</a:t>
            </a:r>
            <a:endParaRPr lang="en-GB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904AE9D6-B12A-0425-837B-C43078AA8BA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8253" y="1025010"/>
            <a:ext cx="5911056" cy="60696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2690779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E4A133E5-DB8D-30FB-461D-7F2E2CC11ADB}"/>
              </a:ext>
            </a:extLst>
          </p:cNvPr>
          <p:cNvSpPr txBox="1"/>
          <p:nvPr/>
        </p:nvSpPr>
        <p:spPr>
          <a:xfrm>
            <a:off x="399402" y="322353"/>
            <a:ext cx="61926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6. Effect of collagen hydrogel thickness on transfection efficiency of PEG-FLR:FLH in NIH3t3 cells.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FF87EA2-2A7E-F92A-33B1-D35DB0947ABC}"/>
              </a:ext>
            </a:extLst>
          </p:cNvPr>
          <p:cNvSpPr txBox="1"/>
          <p:nvPr/>
        </p:nvSpPr>
        <p:spPr>
          <a:xfrm>
            <a:off x="450962" y="7665392"/>
            <a:ext cx="5956075" cy="12234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Figure S6. Effect of collagen hydrogel thickness on transfection efficiency of PEG-FLR:FLH with NIH3t3 cells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A) Luciferase assay of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pGluc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pDNA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transfected NIH3t3 cells (5x10</a:t>
            </a:r>
            <a:r>
              <a:rPr lang="en-GB" sz="105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) in monolayers or in collagen hydrogels (2mg/ml) in thin (20µl) or thick (100µl) geometries using PEG-FLR:FLH (40% PEG 5kDa-FLR/60% FLR or FLR component) at 24h using 1X dose (1µg/ml). B) Metabolic activity (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PrestoBlue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) of NIH3t3 cell monolayers or collagen cells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untransfected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or transfected as in A). </a:t>
            </a:r>
            <a:r>
              <a:rPr lang="en-GB" altLang="en-US" sz="1050" dirty="0" bmk="_Toc773824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ata was normalized to </a:t>
            </a:r>
            <a:r>
              <a:rPr lang="en-GB" altLang="en-US" sz="1050" dirty="0" err="1" bmk="_Toc773824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ntransfected</a:t>
            </a:r>
            <a:r>
              <a:rPr lang="en-GB" altLang="en-US" sz="1050" dirty="0" bmk="_Toc773824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</a:t>
            </a:r>
            <a:r>
              <a:rPr lang="en-GB" altLang="en-US" sz="1050" dirty="0" err="1" bmk="_Toc773824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ntr</a:t>
            </a:r>
            <a:r>
              <a:rPr lang="en-GB" altLang="en-US" sz="1050" dirty="0" bmk="_Toc773824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as 100%. (N=6, bars are S.D. ** p&lt;0.01, * p&lt;0.05).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CD784550-D196-9F76-53B7-CB1CC94E409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42801" y="949302"/>
            <a:ext cx="4572396" cy="66025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0075834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7B6BEFC6-CC84-718A-3A12-35A8313F01B1}"/>
              </a:ext>
            </a:extLst>
          </p:cNvPr>
          <p:cNvSpPr txBox="1"/>
          <p:nvPr/>
        </p:nvSpPr>
        <p:spPr>
          <a:xfrm>
            <a:off x="404664" y="395536"/>
            <a:ext cx="61926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7. Effect of collagen hydrogel thickness on transfection efficiency of different GET nanoparticle dosages in NIH3t3 cells.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D2D63AE-9E65-3785-0C37-B406FAC82D85}"/>
              </a:ext>
            </a:extLst>
          </p:cNvPr>
          <p:cNvSpPr txBox="1"/>
          <p:nvPr/>
        </p:nvSpPr>
        <p:spPr>
          <a:xfrm>
            <a:off x="533645" y="6972366"/>
            <a:ext cx="5775675" cy="12234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Figure S5. Effect of collagen hydrogel thickness on transfection efficiency of different GET nanoparticle dosages with NIH3t3 cells.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A) Luciferase assay of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pGluc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pDNA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transfected NIH3t3 cells (5x10</a:t>
            </a:r>
            <a:r>
              <a:rPr lang="en-GB" sz="105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) in monolayers or in collagen hydrogels (2mg/ml) in thin (20µl) or thick (100µl) geometries using FLR:FLH at 24h using 1X, 2X, 5X, 10X dose (1µg/ml is 1X dose). B) Metabolic activity (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PrestoBlue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) of NIH3t3 cell monolayers or collagen cells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untransfected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or transfected as in A). </a:t>
            </a:r>
            <a:r>
              <a:rPr lang="en-GB" altLang="en-US" sz="1050" dirty="0" bmk="_Toc773824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ata was normalized to </a:t>
            </a:r>
            <a:r>
              <a:rPr lang="en-GB" altLang="en-US" sz="1050" dirty="0" err="1" bmk="_Toc773824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ntransfected</a:t>
            </a:r>
            <a:r>
              <a:rPr lang="en-GB" altLang="en-US" sz="1050" dirty="0" bmk="_Toc773824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</a:t>
            </a:r>
            <a:r>
              <a:rPr lang="en-GB" altLang="en-US" sz="1050" dirty="0" err="1" bmk="_Toc773824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ntr</a:t>
            </a:r>
            <a:r>
              <a:rPr lang="en-GB" altLang="en-US" sz="1050" dirty="0" bmk="_Toc773824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as 100%. (N=6, bars are S.D. ** p&lt;0.01, * p&lt;0.05).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ACE3A952-098D-8332-DBE4-7601763444F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3801" y="1043608"/>
            <a:ext cx="6230397" cy="56218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5564610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/>
          <p:cNvSpPr txBox="1"/>
          <p:nvPr/>
        </p:nvSpPr>
        <p:spPr>
          <a:xfrm>
            <a:off x="404664" y="395536"/>
            <a:ext cx="619268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8. Effect of transfection placement, assay collection and gel concentration on transfection of NIH3t3 cells in collagen hydrogels with NP differential with small pore size membranes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9104BA8-ECE7-4A1E-68A1-A61FBF74DDB0}"/>
              </a:ext>
            </a:extLst>
          </p:cNvPr>
          <p:cNvSpPr txBox="1"/>
          <p:nvPr/>
        </p:nvSpPr>
        <p:spPr>
          <a:xfrm>
            <a:off x="686944" y="7974667"/>
            <a:ext cx="5622376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Figure S8. Effect of transfection placement, assay collection and gel concentration on transfection of NIH3t3 cells in collagen hydrogels with NP differential with small pore size membranes.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Luciferase assay of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pGluc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pDNA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transfection using FLR:FLH 1X dose delivered to NIH3t3 (5x10</a:t>
            </a:r>
            <a:r>
              <a:rPr lang="en-GB" sz="105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) containing collagen gels (2-6mg/ml) measured from bottom A) or top B) media at day 1 (1µg/ml.) with NP differential (0 to -150mmHg). NP was applied from the top </a:t>
            </a:r>
            <a:r>
              <a:rPr lang="en-GB" altLang="en-US" sz="1050" dirty="0" bmk="_Toc773824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N=6, bars are S.D. ** p&lt;0.01, * p&lt;0.05).</a:t>
            </a:r>
            <a:endParaRPr lang="en-GB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2E947CF2-6128-97AD-60FC-3EAB7365D32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3489" y="1293708"/>
            <a:ext cx="5091861" cy="63846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0337815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404664" y="395536"/>
            <a:ext cx="61926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9. Effect of NP differential and different GET nanoparticle dosages on transfection of NIH3t3 cells in collagen hydrogels using 0.4µm membranes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27257A0-D471-2644-232F-ED174EBA68CC}"/>
              </a:ext>
            </a:extLst>
          </p:cNvPr>
          <p:cNvSpPr txBox="1"/>
          <p:nvPr/>
        </p:nvSpPr>
        <p:spPr>
          <a:xfrm>
            <a:off x="495580" y="4274903"/>
            <a:ext cx="5813740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Figure S9. Effect of NP differential and different GET nanoparticles dosages on transfection of NIH3t3 cells in collagen hydrogels using 0.4µm membranes.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Luciferase assay of transfection from bottom well (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pGluc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pDNA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  using FLR:FLH, 0-10X dose) of NIH3t3 (5x10</a:t>
            </a:r>
            <a:r>
              <a:rPr lang="en-GB" sz="105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) containing collagen hydrogels (2mg/ml) measured from top media locations with NP differential (0 to -150 mmHg) at day 1 </a:t>
            </a:r>
            <a:r>
              <a:rPr lang="en-GB" altLang="en-US" sz="1050" dirty="0" bmk="_Toc773824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N=6, bars are S.D. ** p&lt;0.01, * p&lt;0.05 to </a:t>
            </a:r>
            <a:r>
              <a:rPr lang="en-GB" altLang="en-US" sz="1050" dirty="0" err="1" bmk="_Toc773824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ntransfected</a:t>
            </a:r>
            <a:r>
              <a:rPr lang="en-GB" altLang="en-US" sz="1050" dirty="0" bmk="_Toc773824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</a:t>
            </a:r>
            <a:r>
              <a:rPr lang="en-GB" altLang="en-US" sz="1050" dirty="0" err="1" bmk="_Toc773824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tr</a:t>
            </a:r>
            <a:r>
              <a:rPr lang="en-GB" altLang="en-US" sz="1050" dirty="0" bmk="_Toc773824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).</a:t>
            </a:r>
            <a:endParaRPr lang="en-GB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54CB786E-CC9E-5A86-B257-E2BA4809461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2125" y="1119116"/>
            <a:ext cx="5688061" cy="29019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346382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437</TotalTime>
  <Words>2826</Words>
  <Application>Microsoft Office PowerPoint</Application>
  <PresentationFormat>On-screen Show (4:3)</PresentationFormat>
  <Paragraphs>39</Paragraphs>
  <Slides>19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9</vt:i4>
      </vt:variant>
    </vt:vector>
  </HeadingPairs>
  <TitlesOfParts>
    <vt:vector size="22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Nottingha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oN User</dc:creator>
  <cp:lastModifiedBy>James Dixon (staff)</cp:lastModifiedBy>
  <cp:revision>95</cp:revision>
  <cp:lastPrinted>2022-08-14T10:33:58Z</cp:lastPrinted>
  <dcterms:created xsi:type="dcterms:W3CDTF">2018-10-18T13:08:36Z</dcterms:created>
  <dcterms:modified xsi:type="dcterms:W3CDTF">2025-02-25T13:23:41Z</dcterms:modified>
</cp:coreProperties>
</file>